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>
        <p:scale>
          <a:sx n="116" d="100"/>
          <a:sy n="116" d="100"/>
        </p:scale>
        <p:origin x="-1088" y="44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A538-0162-DE46-A2D8-B5F6C8F6561F}" type="datetimeFigureOut">
              <a:rPr lang="en-US" smtClean="0"/>
              <a:t>10/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49F40-8B11-954A-90AA-FDF7361A8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07912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A538-0162-DE46-A2D8-B5F6C8F6561F}" type="datetimeFigureOut">
              <a:rPr lang="en-US" smtClean="0"/>
              <a:t>10/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49F40-8B11-954A-90AA-FDF7361A8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6524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A538-0162-DE46-A2D8-B5F6C8F6561F}" type="datetimeFigureOut">
              <a:rPr lang="en-US" smtClean="0"/>
              <a:t>10/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49F40-8B11-954A-90AA-FDF7361A8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86487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A538-0162-DE46-A2D8-B5F6C8F6561F}" type="datetimeFigureOut">
              <a:rPr lang="en-US" smtClean="0"/>
              <a:t>10/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49F40-8B11-954A-90AA-FDF7361A8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27552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A538-0162-DE46-A2D8-B5F6C8F6561F}" type="datetimeFigureOut">
              <a:rPr lang="en-US" smtClean="0"/>
              <a:t>10/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49F40-8B11-954A-90AA-FDF7361A8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80450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A538-0162-DE46-A2D8-B5F6C8F6561F}" type="datetimeFigureOut">
              <a:rPr lang="en-US" smtClean="0"/>
              <a:t>10/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49F40-8B11-954A-90AA-FDF7361A8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0525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A538-0162-DE46-A2D8-B5F6C8F6561F}" type="datetimeFigureOut">
              <a:rPr lang="en-US" smtClean="0"/>
              <a:t>10/9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49F40-8B11-954A-90AA-FDF7361A8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29995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A538-0162-DE46-A2D8-B5F6C8F6561F}" type="datetimeFigureOut">
              <a:rPr lang="en-US" smtClean="0"/>
              <a:t>10/9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49F40-8B11-954A-90AA-FDF7361A8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0723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A538-0162-DE46-A2D8-B5F6C8F6561F}" type="datetimeFigureOut">
              <a:rPr lang="en-US" smtClean="0"/>
              <a:t>10/9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49F40-8B11-954A-90AA-FDF7361A8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80757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A538-0162-DE46-A2D8-B5F6C8F6561F}" type="datetimeFigureOut">
              <a:rPr lang="en-US" smtClean="0"/>
              <a:t>10/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49F40-8B11-954A-90AA-FDF7361A8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3529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A538-0162-DE46-A2D8-B5F6C8F6561F}" type="datetimeFigureOut">
              <a:rPr lang="en-US" smtClean="0"/>
              <a:t>10/9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49F40-8B11-954A-90AA-FDF7361A8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53112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D2A538-0162-DE46-A2D8-B5F6C8F6561F}" type="datetimeFigureOut">
              <a:rPr lang="en-US" smtClean="0"/>
              <a:t>10/9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549F40-8B11-954A-90AA-FDF7361A8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81716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09486642"/>
              </p:ext>
            </p:extLst>
          </p:nvPr>
        </p:nvGraphicFramePr>
        <p:xfrm>
          <a:off x="171450" y="927100"/>
          <a:ext cx="4635500" cy="4607359"/>
        </p:xfrm>
        <a:graphic>
          <a:graphicData uri="http://schemas.openxmlformats.org/drawingml/2006/table">
            <a:tbl>
              <a:tblPr/>
              <a:tblGrid>
                <a:gridCol w="1562100"/>
                <a:gridCol w="2171700"/>
                <a:gridCol w="901700"/>
              </a:tblGrid>
              <a:tr h="584139">
                <a:tc gridSpan="2"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1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Clinical Parameters</a:t>
                      </a: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Total</a:t>
                      </a:r>
                    </a:p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(N=47)</a:t>
                      </a:r>
                      <a:endParaRPr kumimoji="0" lang="en-US" sz="14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457176"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Age (years)</a:t>
                      </a: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Median</a:t>
                      </a:r>
                    </a:p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(min – max)</a:t>
                      </a: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60</a:t>
                      </a:r>
                    </a:p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(34-85)</a:t>
                      </a: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4303">
                <a:tc rowSpan="4"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Overall Stage (Pathologic)</a:t>
                      </a: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Stage 1</a:t>
                      </a: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20</a:t>
                      </a:r>
                      <a:endParaRPr kumimoji="0" lang="en-US" sz="12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430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Stage 2</a:t>
                      </a: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18</a:t>
                      </a:r>
                      <a:endParaRPr kumimoji="0" lang="en-US" sz="12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</a:tr>
              <a:tr h="27430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Stage 3</a:t>
                      </a: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8</a:t>
                      </a: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27430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Unknown</a:t>
                      </a: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1</a:t>
                      </a: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BFBFBF"/>
                    </a:solidFill>
                  </a:tcPr>
                </a:tc>
              </a:tr>
              <a:tr h="274303">
                <a:tc rowSpan="4"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Grade</a:t>
                      </a: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Grade 1</a:t>
                      </a: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4</a:t>
                      </a: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27430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Grade 2</a:t>
                      </a: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22</a:t>
                      </a:r>
                      <a:endParaRPr kumimoji="0" lang="en-US" sz="12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</a:tr>
              <a:tr h="27430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Grade 3</a:t>
                      </a: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20</a:t>
                      </a:r>
                      <a:endParaRPr kumimoji="0" lang="en-US" sz="12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27430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Unknown</a:t>
                      </a: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1</a:t>
                      </a: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BFBFBF"/>
                    </a:solidFill>
                  </a:tcPr>
                </a:tc>
              </a:tr>
              <a:tr h="274303">
                <a:tc rowSpan="5"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Histologic Subtype</a:t>
                      </a: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Ductal</a:t>
                      </a: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33</a:t>
                      </a:r>
                      <a:endParaRPr kumimoji="0" lang="en-US" sz="12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27430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Lobular</a:t>
                      </a: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3</a:t>
                      </a: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27430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Mixed D/L</a:t>
                      </a: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6</a:t>
                      </a: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27430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Other</a:t>
                      </a: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4</a:t>
                      </a:r>
                      <a:endParaRPr kumimoji="0" lang="en-US" sz="12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27430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Unknown</a:t>
                      </a: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1</a:t>
                      </a:r>
                    </a:p>
                  </a:txBody>
                  <a:tcPr marT="45715" marB="45715"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23100892"/>
              </p:ext>
            </p:extLst>
          </p:nvPr>
        </p:nvGraphicFramePr>
        <p:xfrm>
          <a:off x="5301963" y="2166787"/>
          <a:ext cx="3029176" cy="1719087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303220"/>
                <a:gridCol w="1725956"/>
              </a:tblGrid>
              <a:tr h="621947"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Receptor Status</a:t>
                      </a:r>
                      <a:endParaRPr lang="en-US" sz="1400" b="1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91445" marR="91445" marT="45694" marB="45694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Total</a:t>
                      </a:r>
                    </a:p>
                    <a:p>
                      <a:pPr algn="ctr"/>
                      <a:r>
                        <a:rPr lang="en-US" sz="1400" b="1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(N=47)</a:t>
                      </a:r>
                      <a:endParaRPr lang="en-US" sz="1400" b="1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91445" marR="91445" marT="45694" marB="45694" anchor="ctr"/>
                </a:tc>
              </a:tr>
              <a:tr h="274285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ER+/HER2-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91445" marR="91445" marT="45694" marB="45694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26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91445" marR="91445" marT="45694" marB="45694" anchor="ctr"/>
                </a:tc>
              </a:tr>
              <a:tr h="274285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ER+/HER2+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91445" marR="91445" marT="45694" marB="45694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4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91445" marR="91445" marT="45694" marB="45694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74285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HER2+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91445" marR="91445" marT="45694" marB="45694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5</a:t>
                      </a:r>
                      <a:endParaRPr lang="en-US" sz="1200" b="1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 marL="91445" marR="91445" marT="45694" marB="45694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</a:tr>
              <a:tr h="274285"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/>
                          <a:cs typeface="Arial"/>
                        </a:rPr>
                        <a:t>TNBC</a:t>
                      </a:r>
                      <a:endParaRPr lang="en-US" sz="1200" b="1" dirty="0">
                        <a:latin typeface="Arial"/>
                        <a:cs typeface="Arial"/>
                      </a:endParaRPr>
                    </a:p>
                  </a:txBody>
                  <a:tcPr marL="91445" marR="91445" marT="45694" marB="45694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/>
                          <a:cs typeface="Arial"/>
                        </a:rPr>
                        <a:t>12</a:t>
                      </a:r>
                      <a:endParaRPr lang="en-US" sz="1200" b="1" dirty="0">
                        <a:latin typeface="Arial"/>
                        <a:cs typeface="Arial"/>
                      </a:endParaRPr>
                    </a:p>
                  </a:txBody>
                  <a:tcPr marL="91445" marR="91445" marT="45694" marB="45694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82057" y="41681"/>
            <a:ext cx="22886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l Figure 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134593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4530660"/>
              </p:ext>
            </p:extLst>
          </p:nvPr>
        </p:nvGraphicFramePr>
        <p:xfrm>
          <a:off x="4400550" y="1009650"/>
          <a:ext cx="4445000" cy="4699000"/>
        </p:xfrm>
        <a:graphic>
          <a:graphicData uri="http://schemas.openxmlformats.org/drawingml/2006/table">
            <a:tbl>
              <a:tblPr/>
              <a:tblGrid>
                <a:gridCol w="2286000"/>
                <a:gridCol w="1305213"/>
                <a:gridCol w="853787"/>
              </a:tblGrid>
              <a:tr h="584200">
                <a:tc gridSpan="2"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Clinical Parameters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Total</a:t>
                      </a:r>
                    </a:p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4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(N=47)</a:t>
                      </a:r>
                      <a:endParaRPr kumimoji="0" lang="en-US" sz="14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Race (%AA)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N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68%</a:t>
                      </a:r>
                      <a:endParaRPr kumimoji="0" lang="en-US" sz="12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Recurrent disease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N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6</a:t>
                      </a:r>
                      <a:endParaRPr kumimoji="0" lang="en-US" sz="12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Death (All cause)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N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7</a:t>
                      </a:r>
                      <a:endParaRPr kumimoji="0" lang="en-US" sz="12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Death (Breast cancer)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N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3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</a:tr>
              <a:tr h="0"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Follow-up </a:t>
                      </a:r>
                      <a:r>
                        <a:rPr kumimoji="0" lang="en-US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time (months)</a:t>
                      </a:r>
                      <a:endParaRPr kumimoji="0" lang="en-US" sz="12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Median</a:t>
                      </a:r>
                    </a:p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(min – max)</a:t>
                      </a: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68</a:t>
                      </a:r>
                      <a:endParaRPr kumimoji="0" lang="en-US" sz="12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(1-</a:t>
                      </a:r>
                      <a:r>
                        <a:rPr kumimoji="0" lang="en-US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108)</a:t>
                      </a:r>
                      <a:endParaRPr kumimoji="0" lang="en-US" sz="12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144463">
                <a:tc rowSpan="3"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Surgery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Complete Mastectomy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25</a:t>
                      </a:r>
                      <a:endParaRPr kumimoji="0" lang="en-US" sz="12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BFBFBF"/>
                    </a:solidFill>
                  </a:tcPr>
                </a:tc>
              </a:tr>
              <a:tr h="21113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Partial Mastectomy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22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D9D9D9"/>
                    </a:solidFill>
                  </a:tcPr>
                </a:tc>
              </a:tr>
              <a:tr h="23971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None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0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212725">
                <a:tc rowSpan="2"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Radiation Therapy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Yes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32</a:t>
                      </a:r>
                      <a:endParaRPr kumimoji="0" lang="en-US" sz="12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BFBFBF"/>
                    </a:solidFill>
                  </a:tcPr>
                </a:tc>
              </a:tr>
              <a:tr h="17780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No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15</a:t>
                      </a:r>
                      <a:endParaRPr kumimoji="0" lang="en-US" sz="12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155575">
                <a:tc rowSpan="2"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Adjuvant Chemotherapy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Yes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44</a:t>
                      </a:r>
                      <a:endParaRPr kumimoji="0" lang="en-US" sz="12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BFBFBF"/>
                    </a:solidFill>
                  </a:tcPr>
                </a:tc>
              </a:tr>
              <a:tr h="15557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No</a:t>
                      </a: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3</a:t>
                      </a:r>
                      <a:endParaRPr kumimoji="0" lang="en-US" sz="12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155575"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 dirty="0" err="1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Neoadjuvant</a:t>
                      </a:r>
                      <a:r>
                        <a:rPr kumimoji="0" lang="en-US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 Chemotherapy</a:t>
                      </a:r>
                      <a:endParaRPr kumimoji="0" lang="en-US" sz="12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No</a:t>
                      </a:r>
                      <a:endParaRPr kumimoji="0" lang="en-US" sz="12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charset="0"/>
                          <a:ea typeface="ＭＳ Ｐゴシック" charset="0"/>
                          <a:cs typeface="Arial" charset="0"/>
                        </a:rPr>
                        <a:t>47</a:t>
                      </a:r>
                      <a:endParaRPr kumimoji="0" lang="en-US" sz="1200" b="1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charset="0"/>
                        <a:ea typeface="ＭＳ Ｐゴシック" charset="0"/>
                        <a:cs typeface="Arial" charset="0"/>
                      </a:endParaRPr>
                    </a:p>
                  </a:txBody>
                  <a:tcPr anchor="ctr" horzOverflow="overflow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40937021"/>
              </p:ext>
            </p:extLst>
          </p:nvPr>
        </p:nvGraphicFramePr>
        <p:xfrm>
          <a:off x="263525" y="1568450"/>
          <a:ext cx="3846512" cy="365310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707220"/>
                <a:gridCol w="1391067"/>
                <a:gridCol w="748225"/>
              </a:tblGrid>
              <a:tr h="635104">
                <a:tc gridSpan="2">
                  <a:txBody>
                    <a:bodyPr/>
                    <a:lstStyle/>
                    <a:p>
                      <a:pPr algn="ctr"/>
                      <a:r>
                        <a:rPr lang="en-US" sz="1400" b="1" dirty="0" smtClean="0">
                          <a:latin typeface="Arial"/>
                          <a:cs typeface="Arial"/>
                        </a:rPr>
                        <a:t>Pathologic Parameters</a:t>
                      </a:r>
                      <a:endParaRPr lang="en-US" sz="1400" b="1" dirty="0">
                        <a:latin typeface="Arial"/>
                        <a:cs typeface="Arial"/>
                      </a:endParaRPr>
                    </a:p>
                  </a:txBody>
                  <a:tcPr marL="91445" marR="91445" marT="45727" marB="45727" anchor="ctr"/>
                </a:tc>
                <a:tc hMerge="1">
                  <a:txBody>
                    <a:bodyPr/>
                    <a:lstStyle/>
                    <a:p>
                      <a:endParaRPr lang="en-US" dirty="0"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 smtClean="0">
                          <a:latin typeface="Arial"/>
                          <a:cs typeface="Arial"/>
                        </a:rPr>
                        <a:t>Total</a:t>
                      </a:r>
                    </a:p>
                    <a:p>
                      <a:pPr algn="ctr"/>
                      <a:r>
                        <a:rPr lang="en-US" sz="1400" b="1" dirty="0" smtClean="0">
                          <a:latin typeface="Arial"/>
                          <a:cs typeface="Arial"/>
                        </a:rPr>
                        <a:t>(N=47)</a:t>
                      </a:r>
                      <a:endParaRPr lang="en-US" sz="1400" b="1" dirty="0">
                        <a:latin typeface="Arial"/>
                        <a:cs typeface="Arial"/>
                      </a:endParaRPr>
                    </a:p>
                  </a:txBody>
                  <a:tcPr marL="91445" marR="91445" marT="45727" marB="45727" anchor="ctr"/>
                </a:tc>
              </a:tr>
              <a:tr h="274364">
                <a:tc rowSpan="4"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/>
                          <a:cs typeface="Arial"/>
                        </a:rPr>
                        <a:t>T</a:t>
                      </a:r>
                      <a:r>
                        <a:rPr lang="en-US" sz="1200" b="1" baseline="0" dirty="0" smtClean="0">
                          <a:latin typeface="Arial"/>
                          <a:cs typeface="Arial"/>
                        </a:rPr>
                        <a:t> Stage (Pathologic)</a:t>
                      </a:r>
                      <a:endParaRPr lang="en-US" sz="1200" b="1" dirty="0">
                        <a:latin typeface="Arial"/>
                        <a:cs typeface="Arial"/>
                      </a:endParaRPr>
                    </a:p>
                  </a:txBody>
                  <a:tcPr marL="91445" marR="91445" marT="45727" marB="45727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T0/IS</a:t>
                      </a:r>
                      <a:endParaRPr lang="en-US" sz="12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1445" marR="91445" marT="45727" marB="45727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0</a:t>
                      </a:r>
                      <a:endParaRPr lang="en-US" sz="12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1445" marR="91445" marT="45727" marB="45727" anchor="ctr"/>
                </a:tc>
              </a:tr>
              <a:tr h="274364">
                <a:tc v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T1</a:t>
                      </a:r>
                      <a:endParaRPr lang="en-US" sz="12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1445" marR="91445" marT="45727" marB="45727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27</a:t>
                      </a:r>
                      <a:endParaRPr lang="en-US" sz="12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1445" marR="91445" marT="45727" marB="45727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274364">
                <a:tc v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T2</a:t>
                      </a:r>
                      <a:endParaRPr lang="en-US" sz="12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1445" marR="91445" marT="45727" marB="45727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16</a:t>
                      </a:r>
                      <a:endParaRPr lang="en-US" sz="12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1445" marR="91445" marT="45727" marB="45727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74364">
                <a:tc v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T3</a:t>
                      </a:r>
                      <a:endParaRPr lang="en-US" sz="12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1445" marR="91445" marT="45727" marB="45727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4</a:t>
                      </a:r>
                      <a:endParaRPr lang="en-US" sz="12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1445" marR="91445" marT="45727" marB="45727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</a:tr>
              <a:tr h="274364">
                <a:tc rowSpan="5"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/>
                          <a:cs typeface="Arial"/>
                        </a:rPr>
                        <a:t>N Stage (Pathologic)</a:t>
                      </a:r>
                      <a:endParaRPr lang="en-US" sz="1200" b="1" dirty="0">
                        <a:latin typeface="Arial"/>
                        <a:cs typeface="Arial"/>
                      </a:endParaRPr>
                    </a:p>
                  </a:txBody>
                  <a:tcPr marL="91445" marR="91445" marT="45727" marB="45727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N0</a:t>
                      </a:r>
                      <a:endParaRPr lang="en-US" sz="12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1445" marR="91445" marT="45727" marB="45727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25</a:t>
                      </a:r>
                      <a:endParaRPr lang="en-US" sz="12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1445" marR="91445" marT="45727" marB="45727" anchor="ctr"/>
                </a:tc>
              </a:tr>
              <a:tr h="274364">
                <a:tc v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N1</a:t>
                      </a:r>
                      <a:endParaRPr lang="en-US" sz="12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1445" marR="91445" marT="45727" marB="45727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12</a:t>
                      </a:r>
                      <a:endParaRPr lang="en-US" sz="12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1445" marR="91445" marT="45727" marB="45727"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</a:tr>
              <a:tr h="274364">
                <a:tc v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N2</a:t>
                      </a:r>
                      <a:endParaRPr lang="en-US" sz="12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1445" marR="91445" marT="45727" marB="45727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7</a:t>
                      </a:r>
                      <a:endParaRPr lang="en-US" sz="12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1445" marR="91445" marT="45727" marB="45727" anchor="ctr"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274364">
                <a:tc v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N3</a:t>
                      </a:r>
                      <a:endParaRPr lang="en-US" sz="12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1445" marR="91445" marT="45727" marB="45727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2</a:t>
                      </a:r>
                      <a:endParaRPr lang="en-US" sz="12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1445" marR="91445" marT="45727" marB="45727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</a:tr>
              <a:tr h="274364">
                <a:tc vMerge="1">
                  <a:txBody>
                    <a:bodyPr/>
                    <a:lstStyle/>
                    <a:p>
                      <a:pPr algn="ctr"/>
                      <a:endParaRPr lang="en-US" sz="1200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NX</a:t>
                      </a:r>
                      <a:endParaRPr lang="en-US" sz="12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1445" marR="91445" marT="45727" marB="45727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1</a:t>
                      </a:r>
                      <a:endParaRPr lang="en-US" sz="12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1445" marR="91445" marT="45727" marB="45727" anchor="ctr">
                    <a:solidFill>
                      <a:schemeClr val="bg1">
                        <a:lumMod val="65000"/>
                      </a:schemeClr>
                    </a:solidFill>
                  </a:tcPr>
                </a:tc>
              </a:tr>
              <a:tr h="274364"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latin typeface="Arial"/>
                          <a:cs typeface="Arial"/>
                        </a:rPr>
                        <a:t>M</a:t>
                      </a:r>
                      <a:r>
                        <a:rPr lang="en-US" sz="1200" b="1" baseline="0" dirty="0" smtClean="0">
                          <a:latin typeface="Arial"/>
                          <a:cs typeface="Arial"/>
                        </a:rPr>
                        <a:t> Stage (Pathologic)</a:t>
                      </a:r>
                      <a:endParaRPr lang="en-US" sz="1200" b="1" dirty="0">
                        <a:latin typeface="Arial"/>
                        <a:cs typeface="Arial"/>
                      </a:endParaRPr>
                    </a:p>
                  </a:txBody>
                  <a:tcPr marL="91445" marR="91445" marT="45727" marB="45727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M0</a:t>
                      </a:r>
                      <a:endParaRPr lang="en-US" sz="12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1445" marR="91445" marT="45727" marB="45727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47</a:t>
                      </a:r>
                      <a:endParaRPr lang="en-US" sz="12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1445" marR="91445" marT="45727" marB="45727" anchor="ctr"/>
                </a:tc>
              </a:tr>
              <a:tr h="274364">
                <a:tc vMerge="1">
                  <a:txBody>
                    <a:bodyPr/>
                    <a:lstStyle/>
                    <a:p>
                      <a:pPr algn="ctr"/>
                      <a:endParaRPr lang="en-US" sz="1200" b="1" dirty="0">
                        <a:latin typeface="Arial"/>
                        <a:cs typeface="Arial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M1</a:t>
                      </a:r>
                      <a:endParaRPr lang="en-US" sz="12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1445" marR="91445" marT="45727" marB="45727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0</a:t>
                      </a:r>
                      <a:endParaRPr lang="en-US" sz="12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 marL="91445" marR="91445" marT="45727" marB="45727" anchor="ctr">
                    <a:solidFill>
                      <a:schemeClr val="bg1">
                        <a:lumMod val="75000"/>
                      </a:schemeClr>
                    </a:solidFill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4785979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</TotalTime>
  <Words>220</Words>
  <Application>Microsoft Macintosh PowerPoint</Application>
  <PresentationFormat>On-screen Show (4:3)</PresentationFormat>
  <Paragraphs>117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Harvard Medical Schoo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 1</dc:title>
  <dc:creator>Albert Yeh</dc:creator>
  <cp:lastModifiedBy>Albert Yeh</cp:lastModifiedBy>
  <cp:revision>8</cp:revision>
  <dcterms:created xsi:type="dcterms:W3CDTF">2016-05-28T19:49:17Z</dcterms:created>
  <dcterms:modified xsi:type="dcterms:W3CDTF">2016-10-09T18:44:21Z</dcterms:modified>
</cp:coreProperties>
</file>